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fa-I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RT Pack 20 DVDs" initials="MP2D" lastIdx="1" clrIdx="0">
    <p:extLst>
      <p:ext uri="{19B8F6BF-5375-455C-9EA6-DF929625EA0E}">
        <p15:presenceInfo xmlns:p15="http://schemas.microsoft.com/office/powerpoint/2012/main" userId="MRT Pack 20 DVDs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2466" autoAdjust="0"/>
  </p:normalViewPr>
  <p:slideViewPr>
    <p:cSldViewPr snapToGrid="0">
      <p:cViewPr varScale="1">
        <p:scale>
          <a:sx n="68" d="100"/>
          <a:sy n="68" d="100"/>
        </p:scale>
        <p:origin x="1234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endParaRPr lang="fa-I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fld id="{3582F1FA-6D48-448C-970A-66BE609E95DD}" type="datetimeFigureOut">
              <a:rPr lang="fa-IR" smtClean="0"/>
              <a:t>14/02/1446</a:t>
            </a:fld>
            <a:endParaRPr lang="fa-I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a-I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fld id="{3C074EB9-6B0F-4569-A951-7A63C87761FC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26347501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14/02/1446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499234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14/02/1446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5617887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14/02/1446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37540411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14/02/1446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3671694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14/02/1446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1042833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14/02/1446</a:t>
            </a:fld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4387173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14/02/1446</a:t>
            </a:fld>
            <a:endParaRPr lang="fa-I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21897034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14/02/1446</a:t>
            </a:fld>
            <a:endParaRPr lang="fa-I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3692865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14/02/1446</a:t>
            </a:fld>
            <a:endParaRPr lang="fa-I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25406404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14/02/1446</a:t>
            </a:fld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2002215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a-I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14/02/1446</a:t>
            </a:fld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628824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3623DA-C239-499A-8DAB-661F72BF1177}" type="datetimeFigureOut">
              <a:rPr lang="fa-IR" smtClean="0"/>
              <a:t>14/02/1446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0565403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a-I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10444" y="6110069"/>
            <a:ext cx="11571111" cy="64633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cs typeface="+mj-cs"/>
              </a:rPr>
              <a:t>Fig S1</a:t>
            </a:r>
            <a:r>
              <a:rPr lang="en-US" b="1">
                <a:latin typeface="Times New Roman" panose="02020603050405020304" pitchFamily="18" charset="0"/>
                <a:cs typeface="+mj-cs"/>
              </a:rPr>
              <a:t>. </a:t>
            </a:r>
            <a:r>
              <a:rPr lang="en-US" sz="180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econdary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tructure was drawn by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</a:rPr>
              <a:t>P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ipred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 Yellow arrows represent beta sheets, and pink cylinders represent alpha helix, which are connected by coils.</a:t>
            </a:r>
            <a:endParaRPr lang="fa-IR" dirty="0">
              <a:latin typeface="Times New Roman" panose="02020603050405020304" pitchFamily="18" charset="0"/>
              <a:cs typeface="+mj-cs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322DD35-E6C3-AB4C-615F-918D90675F6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9900" y="-1"/>
            <a:ext cx="5499062" cy="61100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88751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48</TotalTime>
  <Words>29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MRT www.Win2Farsi.co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RT Pack 20 DVDs</dc:creator>
  <cp:lastModifiedBy>red pc</cp:lastModifiedBy>
  <cp:revision>87</cp:revision>
  <dcterms:created xsi:type="dcterms:W3CDTF">2019-03-24T09:48:42Z</dcterms:created>
  <dcterms:modified xsi:type="dcterms:W3CDTF">2024-08-19T13:11:41Z</dcterms:modified>
</cp:coreProperties>
</file>